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16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7284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303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7925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6095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4597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8196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3736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8577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7191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1425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193A6-7423-417A-951A-F3D7CADE118F}" type="datetimeFigureOut">
              <a:rPr lang="es-ES" smtClean="0"/>
              <a:t>09/09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A8AB1-FC21-4B66-B28C-66A88D60B3E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079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2081" y="613063"/>
            <a:ext cx="6123709" cy="6123709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1039091" y="332509"/>
            <a:ext cx="10660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file 2. Average percentage of genome covered with the GBS reads with a read depth from &gt; 1 to &gt; 20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931534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3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eXi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Usuario</cp:lastModifiedBy>
  <cp:revision>1</cp:revision>
  <dcterms:created xsi:type="dcterms:W3CDTF">2016-05-11T10:58:55Z</dcterms:created>
  <dcterms:modified xsi:type="dcterms:W3CDTF">2016-09-09T16:48:32Z</dcterms:modified>
</cp:coreProperties>
</file>